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64" r:id="rId3"/>
    <p:sldId id="275" r:id="rId4"/>
    <p:sldId id="276" r:id="rId5"/>
    <p:sldId id="277" r:id="rId6"/>
    <p:sldId id="278" r:id="rId7"/>
    <p:sldId id="273" r:id="rId8"/>
    <p:sldId id="272" r:id="rId9"/>
    <p:sldId id="265" r:id="rId10"/>
    <p:sldId id="271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10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216" y="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7AAFA04-294D-404D-940A-96B22BFAAF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7FE406C-D564-49E8-9D98-397EC5426C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C1329B-4E81-4AD6-999E-1D46B373E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C4F0C67-DF90-425A-A16E-894D6D824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1965E00-CD6A-4175-8215-9D23F033A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704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3D37002-74BA-4F35-A7DD-B0B0C408D9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D35CDAF-AAE9-4428-8130-CF27FB3ADD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EECE1C5-EC1E-48FD-96DA-1D9B77DC1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91F4363-A5DA-4891-9FE8-707158BC1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001ED5A-744B-40FC-A361-28CF8B477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719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3F4BB58-68C3-442D-800D-397F01FB75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32AA6BC-3F91-48EA-935C-103CBEEE5F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5A8E1FD-D959-488B-B518-5D35C5E2C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7234B5-B6BF-41F1-9EC8-FDCF01A92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76DBDEB-8F63-4A3E-8BCF-9DE8759D7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86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C8369E2-DBCB-4E67-81C8-A00C8758E3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2ECCA55-451F-447E-8662-F161F9A33E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FDA5D1E-C0A6-4448-8C5A-280888BF36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00CB7BB-F0AA-4D86-BAFD-727110249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21A9328-2CF0-407F-B89D-0324B9566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992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E31A40-8ED8-438E-9254-F7B81B40B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965FB02-F76A-4B03-9BE0-C49F6EBEE5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F61A9D1-1D72-4B50-AF06-38A0B1DEBA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20A8A4-AADC-421A-8E2D-800D701EB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6D628FA-18B3-407B-A4A7-0926F62C8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609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8F123F4-F903-4CB3-8D20-6431B1FB6E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81DAC82-39D6-47C1-A2AD-4C653568EF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FA790AC-69C5-4567-97FC-374F58C3D1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EFA141E-370D-4A08-A8CA-B0F677ECE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08560D7-097C-4527-8B1D-35954703C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EDBA235-A3F6-4120-AB7E-62F5F2743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236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8AA11D-1C37-4AD0-8D22-7819838E1C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16164C3-9289-4D10-9BF6-E24A0A8280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995BF7B-9C7F-4ED7-9D9F-8A4B949AE0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10163AE-C5C2-4276-9D46-CF18C26709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23C9425-A3D4-4CB8-8C69-718BB7B525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B23AB4C-88D5-48B7-9E2A-3EACE29D6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A3428D2-C76F-42F6-B4D2-D8A3938DC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F46ADEE-0256-4173-9C48-23FF6F3E2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161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4CC65AB-0BE3-4938-B70F-0476D9C4FB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22EE12EF-9FD9-4150-9546-DBA3FF7C17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A7253E9-37AF-4822-92CB-F6113B7B8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9C9EA0C-5867-4CD8-957A-1EF3F10CD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698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C5D3979-5C95-46E5-8461-6CC10F550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91E6971-9827-4E19-AEBD-BD1EF4996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58D8305-2C4C-4572-BC8D-CE181B4D7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724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3B0B2EC-57F5-4F22-A8D5-46279B401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E30E105-07AC-41BF-92CC-FE049DDFD4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04EE6ED-2BD8-4DE5-979A-16BE747BCF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FD7DCF0-9D0E-4107-B652-03CF0A826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4978A1E-22B8-4B8C-8959-358E107DA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4AD6F7A-90D4-46AF-930A-4F7527544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228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700BBCB-8ABF-49F1-80F6-CE706B9624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1E3C7F9-F834-4582-998C-B3442F1906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CCB2821-F20B-4C4B-8F16-821C5BA088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D93CE84-8510-4659-BC6F-0E4703D9C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F7E5A74-5AA6-4C8C-922A-4E65F50C3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6C1C5C0-F4C5-4E03-9EED-60C27E019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47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69B2DB5-01BE-48D6-8DCD-81513EDBE8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55D4E17-84AE-479D-A68F-9DCE18733A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9F1758-2E80-4F0F-8AE5-017CDD9EFE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868A0-A82A-4F93-9C76-6A6BD447D6C9}" type="datetimeFigureOut">
              <a:rPr lang="en-US" smtClean="0"/>
              <a:t>11/6/20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6670C7A-DBAD-44A6-9830-AAC6B17F99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ECC7510-46DA-4D49-8B89-9E4F464225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164BFF-3BC0-424C-969D-BE79CA9CF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250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1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B06C9BB4-3322-E14C-A070-B1BE70B5E9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751" y="1301836"/>
            <a:ext cx="10974497" cy="32358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67639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ttangolo 12">
            <a:extLst>
              <a:ext uri="{FF2B5EF4-FFF2-40B4-BE49-F238E27FC236}">
                <a16:creationId xmlns:a16="http://schemas.microsoft.com/office/drawing/2014/main" id="{CF7BBE4E-D42A-49D0-B0C0-DBF521869E4E}"/>
              </a:ext>
            </a:extLst>
          </p:cNvPr>
          <p:cNvSpPr/>
          <p:nvPr/>
        </p:nvSpPr>
        <p:spPr>
          <a:xfrm>
            <a:off x="91440" y="70701"/>
            <a:ext cx="118643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91"/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9: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analysis of pSer2448mTOR, mTOR, Atg5-12, LC3 I/II levels in the hippocampus of Euploids and Ts2Cje mice treated with vehicle solution and Thiamet G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7261F46A-F1D1-4BCE-9F06-9AEE90EBEC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069" y="778587"/>
            <a:ext cx="8807862" cy="5738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5578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>
            <a:extLst>
              <a:ext uri="{FF2B5EF4-FFF2-40B4-BE49-F238E27FC236}">
                <a16:creationId xmlns:a16="http://schemas.microsoft.com/office/drawing/2014/main" id="{FC27E0B0-414B-47B4-9573-5EBD9EBDF199}"/>
              </a:ext>
            </a:extLst>
          </p:cNvPr>
          <p:cNvSpPr/>
          <p:nvPr/>
        </p:nvSpPr>
        <p:spPr>
          <a:xfrm>
            <a:off x="-471949" y="94862"/>
            <a:ext cx="12557668" cy="6465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indent="449591"/>
            <a:r>
              <a:rPr lang="en-US" sz="180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r>
              <a:rPr lang="en-US" sz="1801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1: </a:t>
            </a:r>
            <a:r>
              <a:rPr lang="en-US" sz="180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-GlcNAcylation and phosphorylation profile in the hippocampus from Ts2Cje mice at 3, 6, 9 and 12 months of age </a:t>
            </a:r>
          </a:p>
          <a:p>
            <a:pPr indent="449591"/>
            <a:r>
              <a:rPr lang="en-US" sz="180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ed to aged-matched Euploids</a:t>
            </a:r>
            <a:endParaRPr lang="it-IT" sz="180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BEECC6C9-FB8C-467A-8E0D-93556904A2E0}"/>
              </a:ext>
            </a:extLst>
          </p:cNvPr>
          <p:cNvGrpSpPr/>
          <p:nvPr/>
        </p:nvGrpSpPr>
        <p:grpSpPr>
          <a:xfrm>
            <a:off x="205472" y="675860"/>
            <a:ext cx="11047007" cy="6281530"/>
            <a:chOff x="205472" y="576470"/>
            <a:chExt cx="11047007" cy="6281530"/>
          </a:xfrm>
        </p:grpSpPr>
        <p:sp>
          <p:nvSpPr>
            <p:cNvPr id="3" name="Rettangolo 2">
              <a:extLst>
                <a:ext uri="{FF2B5EF4-FFF2-40B4-BE49-F238E27FC236}">
                  <a16:creationId xmlns:a16="http://schemas.microsoft.com/office/drawing/2014/main" id="{31D8AF94-ABCE-40BE-B8F1-685C3DA616C0}"/>
                </a:ext>
              </a:extLst>
            </p:cNvPr>
            <p:cNvSpPr/>
            <p:nvPr/>
          </p:nvSpPr>
          <p:spPr>
            <a:xfrm>
              <a:off x="205472" y="576470"/>
              <a:ext cx="11047007" cy="62815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2" name="Gruppo 1">
              <a:extLst>
                <a:ext uri="{FF2B5EF4-FFF2-40B4-BE49-F238E27FC236}">
                  <a16:creationId xmlns:a16="http://schemas.microsoft.com/office/drawing/2014/main" id="{82176FBF-450D-4AE3-944B-AE28AACD56AC}"/>
                </a:ext>
              </a:extLst>
            </p:cNvPr>
            <p:cNvGrpSpPr/>
            <p:nvPr/>
          </p:nvGrpSpPr>
          <p:grpSpPr>
            <a:xfrm>
              <a:off x="205472" y="741192"/>
              <a:ext cx="10372843" cy="5899470"/>
              <a:chOff x="205472" y="741192"/>
              <a:chExt cx="10372843" cy="5899470"/>
            </a:xfrm>
          </p:grpSpPr>
          <p:pic>
            <p:nvPicPr>
              <p:cNvPr id="5" name="Immagine 4">
                <a:extLst>
                  <a:ext uri="{FF2B5EF4-FFF2-40B4-BE49-F238E27FC236}">
                    <a16:creationId xmlns:a16="http://schemas.microsoft.com/office/drawing/2014/main" id="{1EFF09AC-D98B-4436-83E6-AB5ACF10E7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05472" y="1523563"/>
                <a:ext cx="5969976" cy="3810874"/>
              </a:xfrm>
              <a:prstGeom prst="rect">
                <a:avLst/>
              </a:prstGeom>
            </p:spPr>
          </p:pic>
          <p:pic>
            <p:nvPicPr>
              <p:cNvPr id="160" name="Immagine 159">
                <a:extLst>
                  <a:ext uri="{FF2B5EF4-FFF2-40B4-BE49-F238E27FC236}">
                    <a16:creationId xmlns:a16="http://schemas.microsoft.com/office/drawing/2014/main" id="{A3DA1CA1-7A51-4C48-8EA7-1AC65C1AAF1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b="48719"/>
              <a:stretch/>
            </p:blipFill>
            <p:spPr>
              <a:xfrm>
                <a:off x="6407048" y="741192"/>
                <a:ext cx="4171267" cy="3009398"/>
              </a:xfrm>
              <a:prstGeom prst="rect">
                <a:avLst/>
              </a:prstGeom>
            </p:spPr>
          </p:pic>
          <p:pic>
            <p:nvPicPr>
              <p:cNvPr id="161" name="Immagine 160">
                <a:extLst>
                  <a:ext uri="{FF2B5EF4-FFF2-40B4-BE49-F238E27FC236}">
                    <a16:creationId xmlns:a16="http://schemas.microsoft.com/office/drawing/2014/main" id="{E5E72684-79C9-4645-BC74-250CCAFEE1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51281"/>
              <a:stretch/>
            </p:blipFill>
            <p:spPr>
              <a:xfrm>
                <a:off x="6407047" y="3781586"/>
                <a:ext cx="4171267" cy="2859076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089980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>
            <a:extLst>
              <a:ext uri="{FF2B5EF4-FFF2-40B4-BE49-F238E27FC236}">
                <a16:creationId xmlns:a16="http://schemas.microsoft.com/office/drawing/2014/main" id="{6B62AAAC-BEB8-466A-A6F2-C0395232AD85}"/>
              </a:ext>
            </a:extLst>
          </p:cNvPr>
          <p:cNvGrpSpPr/>
          <p:nvPr/>
        </p:nvGrpSpPr>
        <p:grpSpPr>
          <a:xfrm>
            <a:off x="3063927" y="1010194"/>
            <a:ext cx="5541632" cy="5666712"/>
            <a:chOff x="3063927" y="1010194"/>
            <a:chExt cx="5541632" cy="5666712"/>
          </a:xfrm>
        </p:grpSpPr>
        <p:sp>
          <p:nvSpPr>
            <p:cNvPr id="2" name="Rettangolo 1">
              <a:extLst>
                <a:ext uri="{FF2B5EF4-FFF2-40B4-BE49-F238E27FC236}">
                  <a16:creationId xmlns:a16="http://schemas.microsoft.com/office/drawing/2014/main" id="{E7439AA7-7C3B-4029-9A92-FA2CF5B5D853}"/>
                </a:ext>
              </a:extLst>
            </p:cNvPr>
            <p:cNvSpPr/>
            <p:nvPr/>
          </p:nvSpPr>
          <p:spPr>
            <a:xfrm>
              <a:off x="3065417" y="1010194"/>
              <a:ext cx="5538652" cy="56667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B8BAA754-96DA-4221-8303-46FDF878C7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63927" y="1018672"/>
              <a:ext cx="5541632" cy="5658234"/>
            </a:xfrm>
            <a:prstGeom prst="rect">
              <a:avLst/>
            </a:prstGeom>
          </p:spPr>
        </p:pic>
      </p:grp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CE5902EE-4E8A-48FB-A45B-406B3934E591}"/>
              </a:ext>
            </a:extLst>
          </p:cNvPr>
          <p:cNvSpPr txBox="1"/>
          <p:nvPr/>
        </p:nvSpPr>
        <p:spPr>
          <a:xfrm>
            <a:off x="165463" y="181094"/>
            <a:ext cx="1166077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</a:t>
            </a:r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2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Western blot analysis of GFAP and IBA1 protein expression in the whole hippocampus from 6-months-old Ts2Cje mice and respective Euploid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5446172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>
            <a:extLst>
              <a:ext uri="{FF2B5EF4-FFF2-40B4-BE49-F238E27FC236}">
                <a16:creationId xmlns:a16="http://schemas.microsoft.com/office/drawing/2014/main" id="{73FA570C-BE7D-4BBE-91EB-3A1B6672EE5B}"/>
              </a:ext>
            </a:extLst>
          </p:cNvPr>
          <p:cNvSpPr/>
          <p:nvPr/>
        </p:nvSpPr>
        <p:spPr>
          <a:xfrm>
            <a:off x="141184" y="42029"/>
            <a:ext cx="1155573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91" algn="just"/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3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Western blot and IP analysis of tau and APP PTMs without normalization on respective protein levels. AT8, pSer404 tau, O-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cNAc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au, O-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cNAc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PP an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Se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PP are reported for both 6-months-old Ts2Cje and age-matched euploids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s2Cje and Euploid mice treated with </a:t>
            </a:r>
            <a:r>
              <a:rPr lang="en-US" sz="18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h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 TMG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-F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C51CBD0C-6298-465A-AC72-2DF769120E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0474" y="1116451"/>
            <a:ext cx="9091051" cy="57067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41595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>
            <a:extLst>
              <a:ext uri="{FF2B5EF4-FFF2-40B4-BE49-F238E27FC236}">
                <a16:creationId xmlns:a16="http://schemas.microsoft.com/office/drawing/2014/main" id="{73FA570C-BE7D-4BBE-91EB-3A1B6672EE5B}"/>
              </a:ext>
            </a:extLst>
          </p:cNvPr>
          <p:cNvSpPr/>
          <p:nvPr/>
        </p:nvSpPr>
        <p:spPr>
          <a:xfrm>
            <a:off x="141184" y="42029"/>
            <a:ext cx="1155573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91" algn="just"/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4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dirty="0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Entire IP blots of O-</a:t>
            </a:r>
            <a:r>
              <a:rPr lang="en-US" dirty="0" err="1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GlcNAc</a:t>
            </a:r>
            <a:r>
              <a:rPr lang="en-US" dirty="0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 tau, O-</a:t>
            </a:r>
            <a:r>
              <a:rPr lang="en-US" dirty="0" err="1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GlcNAc</a:t>
            </a:r>
            <a:r>
              <a:rPr lang="en-US" dirty="0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 APP and </a:t>
            </a:r>
            <a:r>
              <a:rPr lang="en-US" dirty="0" err="1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pSer</a:t>
            </a:r>
            <a:r>
              <a:rPr lang="en-US" dirty="0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dirty="0" err="1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Thr</a:t>
            </a:r>
            <a:r>
              <a:rPr lang="en-US" dirty="0">
                <a:latin typeface="Calibir"/>
                <a:ea typeface="Calibri" panose="020F0502020204030204" pitchFamily="34" charset="0"/>
                <a:cs typeface="Times New Roman" panose="02020603050405020304" pitchFamily="18" charset="0"/>
              </a:rPr>
              <a:t> APP overlapped with </a:t>
            </a:r>
            <a:r>
              <a:rPr lang="it-IT" b="0" i="0" dirty="0" err="1">
                <a:solidFill>
                  <a:srgbClr val="333333"/>
                </a:solidFill>
                <a:effectLst/>
                <a:latin typeface="Calibir"/>
              </a:rPr>
              <a:t>molecular</a:t>
            </a:r>
            <a:r>
              <a:rPr lang="it-IT" b="0" i="0" dirty="0">
                <a:solidFill>
                  <a:srgbClr val="333333"/>
                </a:solidFill>
                <a:effectLst/>
                <a:latin typeface="Calibir"/>
              </a:rPr>
              <a:t> weight standards. </a:t>
            </a:r>
            <a:r>
              <a:rPr lang="it-IT" b="0" i="0" dirty="0" err="1">
                <a:solidFill>
                  <a:srgbClr val="333333"/>
                </a:solidFill>
                <a:effectLst/>
                <a:latin typeface="Calibir"/>
              </a:rPr>
              <a:t>Blots</a:t>
            </a:r>
            <a:r>
              <a:rPr lang="it-IT" b="0" i="0" dirty="0">
                <a:solidFill>
                  <a:srgbClr val="333333"/>
                </a:solidFill>
                <a:effectLst/>
                <a:latin typeface="Calibir"/>
              </a:rPr>
              <a:t> ar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ported for both 6-months-old Ts2Cje and age-matched euploids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-B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s2Cje and Euploid mice treated with </a:t>
            </a:r>
            <a:r>
              <a:rPr lang="en-US" sz="18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h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 TMG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-D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it-IT" dirty="0">
              <a:latin typeface="Calibi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D9D49642-5F2A-4B5D-B8B0-EA07D4979E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902" y="1367245"/>
            <a:ext cx="10432059" cy="50335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42921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2B3EE277-D91D-4E69-BA75-E54B3DC00854}"/>
              </a:ext>
            </a:extLst>
          </p:cNvPr>
          <p:cNvGrpSpPr/>
          <p:nvPr/>
        </p:nvGrpSpPr>
        <p:grpSpPr>
          <a:xfrm>
            <a:off x="2910124" y="853440"/>
            <a:ext cx="5781030" cy="6133653"/>
            <a:chOff x="2910124" y="853440"/>
            <a:chExt cx="5781030" cy="6133653"/>
          </a:xfrm>
        </p:grpSpPr>
        <p:sp>
          <p:nvSpPr>
            <p:cNvPr id="2" name="Rettangolo 1">
              <a:extLst>
                <a:ext uri="{FF2B5EF4-FFF2-40B4-BE49-F238E27FC236}">
                  <a16:creationId xmlns:a16="http://schemas.microsoft.com/office/drawing/2014/main" id="{A09CEDE0-AE8F-46F0-866C-EF2105FF53D1}"/>
                </a:ext>
              </a:extLst>
            </p:cNvPr>
            <p:cNvSpPr/>
            <p:nvPr/>
          </p:nvSpPr>
          <p:spPr>
            <a:xfrm>
              <a:off x="2910124" y="853440"/>
              <a:ext cx="5781030" cy="584627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373B3B72-B148-49A8-9EDB-BD896B6D40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10124" y="1140822"/>
              <a:ext cx="5642148" cy="5846271"/>
            </a:xfrm>
            <a:prstGeom prst="rect">
              <a:avLst/>
            </a:prstGeom>
          </p:spPr>
        </p:pic>
      </p:grpSp>
      <p:sp>
        <p:nvSpPr>
          <p:cNvPr id="5" name="Rettangolo 4">
            <a:extLst>
              <a:ext uri="{FF2B5EF4-FFF2-40B4-BE49-F238E27FC236}">
                <a16:creationId xmlns:a16="http://schemas.microsoft.com/office/drawing/2014/main" id="{F4437593-005E-49C6-8C77-11F4BE6C716B}"/>
              </a:ext>
            </a:extLst>
          </p:cNvPr>
          <p:cNvSpPr/>
          <p:nvPr/>
        </p:nvSpPr>
        <p:spPr>
          <a:xfrm>
            <a:off x="171450" y="70701"/>
            <a:ext cx="1155573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91" algn="just"/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5: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analysis of GSK3</a:t>
            </a:r>
            <a:r>
              <a:rPr lang="el-GR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ctivation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tate in the </a:t>
            </a:r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ippocampus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6-months-old Ts2Cje mice </a:t>
            </a:r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ed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it-IT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uploids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it-IT" dirty="0" err="1">
                <a:ea typeface="Calibri" panose="020F0502020204030204" pitchFamily="34" charset="0"/>
                <a:cs typeface="Calibri" panose="020F0502020204030204" pitchFamily="34" charset="0"/>
              </a:rPr>
              <a:t>Phosphorylation</a:t>
            </a:r>
            <a:r>
              <a:rPr lang="it-IT" dirty="0">
                <a:ea typeface="Calibri" panose="020F0502020204030204" pitchFamily="34" charset="0"/>
                <a:cs typeface="Calibri" panose="020F0502020204030204" pitchFamily="34" charset="0"/>
              </a:rPr>
              <a:t> on Ser9 (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inhibitory site </a:t>
            </a:r>
            <a:r>
              <a:rPr lang="it-IT" dirty="0">
                <a:ea typeface="Calibri" panose="020F0502020204030204" pitchFamily="34" charset="0"/>
                <a:cs typeface="Calibri" panose="020F0502020204030204" pitchFamily="34" charset="0"/>
              </a:rPr>
              <a:t>) and Tyr216 (</a:t>
            </a:r>
            <a:r>
              <a:rPr lang="en-US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activatory</a:t>
            </a: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site)</a:t>
            </a:r>
            <a:r>
              <a:rPr lang="it-IT" dirty="0"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dirty="0" err="1">
                <a:ea typeface="Calibri" panose="020F0502020204030204" pitchFamily="34" charset="0"/>
                <a:cs typeface="Calibri" panose="020F0502020204030204" pitchFamily="34" charset="0"/>
              </a:rPr>
              <a:t>was</a:t>
            </a:r>
            <a:r>
              <a:rPr lang="it-IT" dirty="0"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it-IT" dirty="0" err="1">
                <a:ea typeface="Calibri" panose="020F0502020204030204" pitchFamily="34" charset="0"/>
                <a:cs typeface="Calibri" panose="020F0502020204030204" pitchFamily="34" charset="0"/>
              </a:rPr>
              <a:t>evaluated</a:t>
            </a:r>
            <a:r>
              <a:rPr lang="it-IT" dirty="0"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endParaRPr lang="it-IT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98961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F32D24AC-D7CD-4D05-BA28-D01D61AF5720}"/>
              </a:ext>
            </a:extLst>
          </p:cNvPr>
          <p:cNvSpPr/>
          <p:nvPr/>
        </p:nvSpPr>
        <p:spPr>
          <a:xfrm>
            <a:off x="171450" y="70701"/>
            <a:ext cx="1155573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91" algn="just"/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6: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analysis of AS160 expression levels and phosphorylation on Thr642, and of GLUT1, GLUT3 and GLUT4 expression levels in the hippocampus of Ts2Cje mice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B79550CE-EA9C-4DB5-BEC7-5F1A129BE2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3862" y="1049542"/>
            <a:ext cx="8189105" cy="5579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48008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B21D6406-C432-427E-8000-33C4B5E49666}"/>
              </a:ext>
            </a:extLst>
          </p:cNvPr>
          <p:cNvGrpSpPr/>
          <p:nvPr/>
        </p:nvGrpSpPr>
        <p:grpSpPr>
          <a:xfrm>
            <a:off x="600263" y="1248745"/>
            <a:ext cx="10823140" cy="4820751"/>
            <a:chOff x="600263" y="1248745"/>
            <a:chExt cx="10823140" cy="4820751"/>
          </a:xfrm>
        </p:grpSpPr>
        <p:sp>
          <p:nvSpPr>
            <p:cNvPr id="3" name="Rettangolo 2">
              <a:extLst>
                <a:ext uri="{FF2B5EF4-FFF2-40B4-BE49-F238E27FC236}">
                  <a16:creationId xmlns:a16="http://schemas.microsoft.com/office/drawing/2014/main" id="{2822DBAA-32E9-4434-A8AB-1F9EB3E4C113}"/>
                </a:ext>
              </a:extLst>
            </p:cNvPr>
            <p:cNvSpPr/>
            <p:nvPr/>
          </p:nvSpPr>
          <p:spPr>
            <a:xfrm>
              <a:off x="600263" y="1248745"/>
              <a:ext cx="10823140" cy="482075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30" name="Gruppo 29">
              <a:extLst>
                <a:ext uri="{FF2B5EF4-FFF2-40B4-BE49-F238E27FC236}">
                  <a16:creationId xmlns:a16="http://schemas.microsoft.com/office/drawing/2014/main" id="{9BBBB3C3-1983-4E23-955A-43F8859CB5D8}"/>
                </a:ext>
              </a:extLst>
            </p:cNvPr>
            <p:cNvGrpSpPr/>
            <p:nvPr/>
          </p:nvGrpSpPr>
          <p:grpSpPr>
            <a:xfrm>
              <a:off x="671178" y="1248745"/>
              <a:ext cx="10503454" cy="4727985"/>
              <a:chOff x="684430" y="1169232"/>
              <a:chExt cx="10503454" cy="4727985"/>
            </a:xfrm>
          </p:grpSpPr>
          <p:pic>
            <p:nvPicPr>
              <p:cNvPr id="25" name="Immagine 24">
                <a:extLst>
                  <a:ext uri="{FF2B5EF4-FFF2-40B4-BE49-F238E27FC236}">
                    <a16:creationId xmlns:a16="http://schemas.microsoft.com/office/drawing/2014/main" id="{3BB01D5A-6DA8-4001-8F71-80D553AB42B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84430" y="2068643"/>
                <a:ext cx="5340655" cy="2384470"/>
              </a:xfrm>
              <a:prstGeom prst="rect">
                <a:avLst/>
              </a:prstGeom>
            </p:spPr>
          </p:pic>
          <p:pic>
            <p:nvPicPr>
              <p:cNvPr id="29" name="Immagine 28">
                <a:extLst>
                  <a:ext uri="{FF2B5EF4-FFF2-40B4-BE49-F238E27FC236}">
                    <a16:creationId xmlns:a16="http://schemas.microsoft.com/office/drawing/2014/main" id="{6F1F1B73-D468-47B5-9119-DC1DECC68D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b="10879"/>
              <a:stretch/>
            </p:blipFill>
            <p:spPr>
              <a:xfrm>
                <a:off x="5913830" y="1169232"/>
                <a:ext cx="5274054" cy="4727985"/>
              </a:xfrm>
              <a:prstGeom prst="rect">
                <a:avLst/>
              </a:prstGeom>
            </p:spPr>
          </p:pic>
        </p:grpSp>
      </p:grpSp>
      <p:sp>
        <p:nvSpPr>
          <p:cNvPr id="8" name="Rettangolo 7">
            <a:extLst>
              <a:ext uri="{FF2B5EF4-FFF2-40B4-BE49-F238E27FC236}">
                <a16:creationId xmlns:a16="http://schemas.microsoft.com/office/drawing/2014/main" id="{CE5475E2-8469-7742-8B70-7683FB40D55A}"/>
              </a:ext>
            </a:extLst>
          </p:cNvPr>
          <p:cNvSpPr/>
          <p:nvPr/>
        </p:nvSpPr>
        <p:spPr>
          <a:xfrm>
            <a:off x="171450" y="70701"/>
            <a:ext cx="1155573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91" algn="just"/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7: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analysis of total protein O-GlcNAcylation levels in the hippocampus of mice subjected to increasing dosage of Thiamet G by intranasal delivery (Dose-response)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85637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o 13">
            <a:extLst>
              <a:ext uri="{FF2B5EF4-FFF2-40B4-BE49-F238E27FC236}">
                <a16:creationId xmlns:a16="http://schemas.microsoft.com/office/drawing/2014/main" id="{68129C2B-867F-4221-AD32-5E1E9AFF6469}"/>
              </a:ext>
            </a:extLst>
          </p:cNvPr>
          <p:cNvGrpSpPr/>
          <p:nvPr/>
        </p:nvGrpSpPr>
        <p:grpSpPr>
          <a:xfrm>
            <a:off x="2405589" y="914400"/>
            <a:ext cx="7298481" cy="5667989"/>
            <a:chOff x="1868379" y="170092"/>
            <a:chExt cx="8455242" cy="6629467"/>
          </a:xfrm>
        </p:grpSpPr>
        <p:sp>
          <p:nvSpPr>
            <p:cNvPr id="4" name="Rettangolo 3">
              <a:extLst>
                <a:ext uri="{FF2B5EF4-FFF2-40B4-BE49-F238E27FC236}">
                  <a16:creationId xmlns:a16="http://schemas.microsoft.com/office/drawing/2014/main" id="{25CB8C5E-3484-478A-9652-AD2C3AE56E7A}"/>
                </a:ext>
              </a:extLst>
            </p:cNvPr>
            <p:cNvSpPr/>
            <p:nvPr/>
          </p:nvSpPr>
          <p:spPr>
            <a:xfrm>
              <a:off x="1868379" y="170092"/>
              <a:ext cx="8455242" cy="662946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575E8F1F-954A-4FEF-9E8B-FD2AB9FCB39E}"/>
                </a:ext>
              </a:extLst>
            </p:cNvPr>
            <p:cNvGrpSpPr/>
            <p:nvPr/>
          </p:nvGrpSpPr>
          <p:grpSpPr>
            <a:xfrm>
              <a:off x="1868379" y="394899"/>
              <a:ext cx="8242446" cy="6305269"/>
              <a:chOff x="1868378" y="394898"/>
              <a:chExt cx="8242447" cy="6305270"/>
            </a:xfrm>
          </p:grpSpPr>
          <p:pic>
            <p:nvPicPr>
              <p:cNvPr id="10" name="Immagine 9" descr="Immagine che contiene disegnando, computer&#10;&#10;Descrizione generata automaticamente">
                <a:extLst>
                  <a:ext uri="{FF2B5EF4-FFF2-40B4-BE49-F238E27FC236}">
                    <a16:creationId xmlns:a16="http://schemas.microsoft.com/office/drawing/2014/main" id="{0D3D7F84-F484-451D-A2DB-BA6DC74D07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68378" y="3200295"/>
                <a:ext cx="3343615" cy="3481074"/>
              </a:xfrm>
              <a:prstGeom prst="rect">
                <a:avLst/>
              </a:prstGeom>
            </p:spPr>
          </p:pic>
          <p:pic>
            <p:nvPicPr>
              <p:cNvPr id="11" name="Immagine 10" descr="Immagine che contiene luce&#10;&#10;Descrizione generata automaticamente">
                <a:extLst>
                  <a:ext uri="{FF2B5EF4-FFF2-40B4-BE49-F238E27FC236}">
                    <a16:creationId xmlns:a16="http://schemas.microsoft.com/office/drawing/2014/main" id="{DB79BF4D-C28E-4A1F-B69D-DAE63546B6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82978" y="3200295"/>
                <a:ext cx="3287981" cy="3499873"/>
              </a:xfrm>
              <a:prstGeom prst="rect">
                <a:avLst/>
              </a:prstGeom>
            </p:spPr>
          </p:pic>
          <p:pic>
            <p:nvPicPr>
              <p:cNvPr id="12" name="Immagine 11" descr="Immagine che contiene computer, porta, disegnando&#10;&#10;Descrizione generata automaticamente">
                <a:extLst>
                  <a:ext uri="{FF2B5EF4-FFF2-40B4-BE49-F238E27FC236}">
                    <a16:creationId xmlns:a16="http://schemas.microsoft.com/office/drawing/2014/main" id="{2531999A-F180-4C78-8679-1B5F59658E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22844" y="3200295"/>
                <a:ext cx="3287981" cy="3499873"/>
              </a:xfrm>
              <a:prstGeom prst="rect">
                <a:avLst/>
              </a:prstGeom>
            </p:spPr>
          </p:pic>
          <p:pic>
            <p:nvPicPr>
              <p:cNvPr id="13" name="Immagine 12">
                <a:extLst>
                  <a:ext uri="{FF2B5EF4-FFF2-40B4-BE49-F238E27FC236}">
                    <a16:creationId xmlns:a16="http://schemas.microsoft.com/office/drawing/2014/main" id="{60EF8B62-3800-4F8E-86E4-B026886C15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055954" y="394898"/>
                <a:ext cx="5661861" cy="2534568"/>
              </a:xfrm>
              <a:prstGeom prst="rect">
                <a:avLst/>
              </a:prstGeom>
            </p:spPr>
          </p:pic>
        </p:grpSp>
      </p:grp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DB247C04-6A52-47CB-9E1C-91E1E9CE2D46}"/>
              </a:ext>
            </a:extLst>
          </p:cNvPr>
          <p:cNvSpPr txBox="1"/>
          <p:nvPr/>
        </p:nvSpPr>
        <p:spPr>
          <a:xfrm>
            <a:off x="226423" y="183273"/>
            <a:ext cx="115214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49591"/>
            <a:r>
              <a:rPr lang="en-US" sz="1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8: 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analysis of APP, </a:t>
            </a:r>
            <a:r>
              <a:rPr lang="en-US" sz="1800" dirty="0"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CTF and </a:t>
            </a:r>
            <a:r>
              <a:rPr lang="en-US" sz="1800" dirty="0"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ea typeface="Calibri" panose="020F0502020204030204" pitchFamily="34" charset="0"/>
                <a:cs typeface="Times New Roman" panose="02020603050405020304" pitchFamily="18" charset="0"/>
              </a:rPr>
              <a:t>-CTF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evels in the hippocampus of Euploids and Ts2Cje mice treated with vehicle solution and </a:t>
            </a:r>
            <a:r>
              <a:rPr lang="en-US" sz="18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iamet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</a:t>
            </a:r>
            <a:endParaRPr lang="it-IT" sz="1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67305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3</TotalTime>
  <Words>321</Words>
  <Application>Microsoft Macintosh PowerPoint</Application>
  <PresentationFormat>Widescreen</PresentationFormat>
  <Paragraphs>10</Paragraphs>
  <Slides>10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0</vt:i4>
      </vt:variant>
    </vt:vector>
  </HeadingPairs>
  <TitlesOfParts>
    <vt:vector size="16" baseType="lpstr">
      <vt:lpstr>Arial</vt:lpstr>
      <vt:lpstr>Calibir</vt:lpstr>
      <vt:lpstr>Calibri</vt:lpstr>
      <vt:lpstr>Calibri Light</vt:lpstr>
      <vt:lpstr>Symbol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laria</dc:creator>
  <cp:lastModifiedBy>Fabio Di Domenico</cp:lastModifiedBy>
  <cp:revision>98</cp:revision>
  <dcterms:created xsi:type="dcterms:W3CDTF">2020-06-30T06:39:15Z</dcterms:created>
  <dcterms:modified xsi:type="dcterms:W3CDTF">2020-11-06T08:55:54Z</dcterms:modified>
</cp:coreProperties>
</file>